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01992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620D8C5-C5E4-40D9-9C4D-B2E3FED5F21F}" v="668" dt="2024-02-27T14:51:22.42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7974" autoAdjust="0"/>
  </p:normalViewPr>
  <p:slideViewPr>
    <p:cSldViewPr snapToGrid="0">
      <p:cViewPr varScale="1">
        <p:scale>
          <a:sx n="86" d="100"/>
          <a:sy n="86" d="100"/>
        </p:scale>
        <p:origin x="290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AB6AE6-5FAF-3248-BF68-6011CC3BBC8A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143000"/>
            <a:ext cx="2368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6DC637-D012-6345-BDAA-4B050B2B8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7677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6DC637-D012-6345-BDAA-4B050B2B8CD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2971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6495" y="1496484"/>
            <a:ext cx="5966936" cy="3183467"/>
          </a:xfrm>
        </p:spPr>
        <p:txBody>
          <a:bodyPr anchor="b"/>
          <a:lstStyle>
            <a:lvl1pPr algn="ctr">
              <a:defRPr sz="460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7491" y="4802717"/>
            <a:ext cx="5264944" cy="2207683"/>
          </a:xfrm>
        </p:spPr>
        <p:txBody>
          <a:bodyPr/>
          <a:lstStyle>
            <a:lvl1pPr marL="0" indent="0" algn="ctr">
              <a:buNone/>
              <a:defRPr sz="1842"/>
            </a:lvl1pPr>
            <a:lvl2pPr marL="350992" indent="0" algn="ctr">
              <a:buNone/>
              <a:defRPr sz="1535"/>
            </a:lvl2pPr>
            <a:lvl3pPr marL="701985" indent="0" algn="ctr">
              <a:buNone/>
              <a:defRPr sz="1382"/>
            </a:lvl3pPr>
            <a:lvl4pPr marL="1052977" indent="0" algn="ctr">
              <a:buNone/>
              <a:defRPr sz="1228"/>
            </a:lvl4pPr>
            <a:lvl5pPr marL="1403970" indent="0" algn="ctr">
              <a:buNone/>
              <a:defRPr sz="1228"/>
            </a:lvl5pPr>
            <a:lvl6pPr marL="1754962" indent="0" algn="ctr">
              <a:buNone/>
              <a:defRPr sz="1228"/>
            </a:lvl6pPr>
            <a:lvl7pPr marL="2105955" indent="0" algn="ctr">
              <a:buNone/>
              <a:defRPr sz="1228"/>
            </a:lvl7pPr>
            <a:lvl8pPr marL="2456947" indent="0" algn="ctr">
              <a:buNone/>
              <a:defRPr sz="1228"/>
            </a:lvl8pPr>
            <a:lvl9pPr marL="2807940" indent="0" algn="ctr">
              <a:buNone/>
              <a:defRPr sz="1228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399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195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23634" y="486834"/>
            <a:ext cx="1513671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2620" y="486834"/>
            <a:ext cx="4453265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395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8964" y="2279653"/>
            <a:ext cx="6054685" cy="3803649"/>
          </a:xfrm>
        </p:spPr>
        <p:txBody>
          <a:bodyPr anchor="b"/>
          <a:lstStyle>
            <a:lvl1pPr>
              <a:defRPr sz="460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8964" y="6119286"/>
            <a:ext cx="6054685" cy="2000249"/>
          </a:xfrm>
        </p:spPr>
        <p:txBody>
          <a:bodyPr/>
          <a:lstStyle>
            <a:lvl1pPr marL="0" indent="0">
              <a:buNone/>
              <a:defRPr sz="1842">
                <a:solidFill>
                  <a:schemeClr val="tx1"/>
                </a:solidFill>
              </a:defRPr>
            </a:lvl1pPr>
            <a:lvl2pPr marL="350992" indent="0">
              <a:buNone/>
              <a:defRPr sz="1535">
                <a:solidFill>
                  <a:schemeClr val="tx1">
                    <a:tint val="75000"/>
                  </a:schemeClr>
                </a:solidFill>
              </a:defRPr>
            </a:lvl2pPr>
            <a:lvl3pPr marL="701985" indent="0">
              <a:buNone/>
              <a:defRPr sz="1382">
                <a:solidFill>
                  <a:schemeClr val="tx1">
                    <a:tint val="75000"/>
                  </a:schemeClr>
                </a:solidFill>
              </a:defRPr>
            </a:lvl3pPr>
            <a:lvl4pPr marL="105297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4pPr>
            <a:lvl5pPr marL="140397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5pPr>
            <a:lvl6pPr marL="1754962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6pPr>
            <a:lvl7pPr marL="2105955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7pPr>
            <a:lvl8pPr marL="245694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8pPr>
            <a:lvl9pPr marL="280794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5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2620" y="2434167"/>
            <a:ext cx="2983468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53837" y="2434167"/>
            <a:ext cx="2983468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448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486836"/>
            <a:ext cx="605468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35" y="2241551"/>
            <a:ext cx="2969757" cy="1098549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3535" y="3340100"/>
            <a:ext cx="2969757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53838" y="2241551"/>
            <a:ext cx="2984382" cy="1098549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53838" y="3340100"/>
            <a:ext cx="2984382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397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841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682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609600"/>
            <a:ext cx="2264109" cy="2133600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84382" y="1316569"/>
            <a:ext cx="3553837" cy="6498167"/>
          </a:xfrm>
        </p:spPr>
        <p:txBody>
          <a:bodyPr/>
          <a:lstStyle>
            <a:lvl1pPr>
              <a:defRPr sz="2457"/>
            </a:lvl1pPr>
            <a:lvl2pPr>
              <a:defRPr sz="2150"/>
            </a:lvl2pPr>
            <a:lvl3pPr>
              <a:defRPr sz="1842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743200"/>
            <a:ext cx="2264109" cy="5082117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092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609600"/>
            <a:ext cx="2264109" cy="2133600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84382" y="1316569"/>
            <a:ext cx="3553837" cy="6498167"/>
          </a:xfrm>
        </p:spPr>
        <p:txBody>
          <a:bodyPr anchor="t"/>
          <a:lstStyle>
            <a:lvl1pPr marL="0" indent="0">
              <a:buNone/>
              <a:defRPr sz="2457"/>
            </a:lvl1pPr>
            <a:lvl2pPr marL="350992" indent="0">
              <a:buNone/>
              <a:defRPr sz="2150"/>
            </a:lvl2pPr>
            <a:lvl3pPr marL="701985" indent="0">
              <a:buNone/>
              <a:defRPr sz="1842"/>
            </a:lvl3pPr>
            <a:lvl4pPr marL="1052977" indent="0">
              <a:buNone/>
              <a:defRPr sz="1535"/>
            </a:lvl4pPr>
            <a:lvl5pPr marL="1403970" indent="0">
              <a:buNone/>
              <a:defRPr sz="1535"/>
            </a:lvl5pPr>
            <a:lvl6pPr marL="1754962" indent="0">
              <a:buNone/>
              <a:defRPr sz="1535"/>
            </a:lvl6pPr>
            <a:lvl7pPr marL="2105955" indent="0">
              <a:buNone/>
              <a:defRPr sz="1535"/>
            </a:lvl7pPr>
            <a:lvl8pPr marL="2456947" indent="0">
              <a:buNone/>
              <a:defRPr sz="1535"/>
            </a:lvl8pPr>
            <a:lvl9pPr marL="2807940" indent="0">
              <a:buNone/>
              <a:defRPr sz="1535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743200"/>
            <a:ext cx="2264109" cy="5082117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377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2620" y="486836"/>
            <a:ext cx="605468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2620" y="2434167"/>
            <a:ext cx="605468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2620" y="8475136"/>
            <a:ext cx="157948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CA80D-52BA-8E4A-A435-97FDC5072892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25350" y="8475136"/>
            <a:ext cx="236922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57822" y="8475136"/>
            <a:ext cx="157948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B93E7-DFC5-BD40-83CA-1887134AC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603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01985" rtl="0" eaLnBrk="1" latinLnBrk="0" hangingPunct="1">
        <a:lnSpc>
          <a:spcPct val="90000"/>
        </a:lnSpc>
        <a:spcBef>
          <a:spcPct val="0"/>
        </a:spcBef>
        <a:buNone/>
        <a:defRPr sz="3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496" indent="-175496" algn="l" defTabSz="701985" rtl="0" eaLnBrk="1" latinLnBrk="0" hangingPunct="1">
        <a:lnSpc>
          <a:spcPct val="90000"/>
        </a:lnSpc>
        <a:spcBef>
          <a:spcPts val="768"/>
        </a:spcBef>
        <a:buFont typeface="Arial" panose="020B0604020202020204" pitchFamily="34" charset="0"/>
        <a:buChar char="•"/>
        <a:defRPr sz="2150" kern="1200">
          <a:solidFill>
            <a:schemeClr val="tx1"/>
          </a:solidFill>
          <a:latin typeface="+mn-lt"/>
          <a:ea typeface="+mn-ea"/>
          <a:cs typeface="+mn-cs"/>
        </a:defRPr>
      </a:lvl1pPr>
      <a:lvl2pPr marL="526489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87748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228474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57946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930458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28145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632443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98343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2pPr>
      <a:lvl3pPr marL="70198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3pPr>
      <a:lvl4pPr marL="105297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75496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10595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45694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80794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9.png"/><Relationship Id="rId18" Type="http://schemas.microsoft.com/office/2007/relationships/hdphoto" Target="../media/hdphoto5.wdp"/><Relationship Id="rId26" Type="http://schemas.microsoft.com/office/2007/relationships/hdphoto" Target="../media/hdphoto9.wdp"/><Relationship Id="rId3" Type="http://schemas.openxmlformats.org/officeDocument/2006/relationships/image" Target="../media/image1.png"/><Relationship Id="rId21" Type="http://schemas.openxmlformats.org/officeDocument/2006/relationships/image" Target="../media/image13.png"/><Relationship Id="rId7" Type="http://schemas.openxmlformats.org/officeDocument/2006/relationships/image" Target="../media/image5.png"/><Relationship Id="rId12" Type="http://schemas.microsoft.com/office/2007/relationships/hdphoto" Target="../media/hdphoto2.wdp"/><Relationship Id="rId17" Type="http://schemas.openxmlformats.org/officeDocument/2006/relationships/image" Target="../media/image11.png"/><Relationship Id="rId25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20" Type="http://schemas.microsoft.com/office/2007/relationships/hdphoto" Target="../media/hdphoto6.wdp"/><Relationship Id="rId29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24" Type="http://schemas.microsoft.com/office/2007/relationships/hdphoto" Target="../media/hdphoto8.wdp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23" Type="http://schemas.openxmlformats.org/officeDocument/2006/relationships/image" Target="../media/image14.png"/><Relationship Id="rId28" Type="http://schemas.microsoft.com/office/2007/relationships/hdphoto" Target="../media/hdphoto10.wdp"/><Relationship Id="rId10" Type="http://schemas.microsoft.com/office/2007/relationships/hdphoto" Target="../media/hdphoto1.wdp"/><Relationship Id="rId19" Type="http://schemas.openxmlformats.org/officeDocument/2006/relationships/image" Target="../media/image12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microsoft.com/office/2007/relationships/hdphoto" Target="../media/hdphoto3.wdp"/><Relationship Id="rId22" Type="http://schemas.microsoft.com/office/2007/relationships/hdphoto" Target="../media/hdphoto7.wdp"/><Relationship Id="rId27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089A35F-FAEA-8787-40D7-F0E74F12E1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38434" y="2099570"/>
            <a:ext cx="1790700" cy="1447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3923E87-657E-A15C-BC10-CAE67FB114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3950" y="3765448"/>
            <a:ext cx="1795954" cy="150689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535C8EE-1043-FB25-1F3B-D9287C7694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2271" y="2031752"/>
            <a:ext cx="1757234" cy="149608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EF89338-A495-D80D-BB13-F5FC7AA9E5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32356" y="3545080"/>
            <a:ext cx="2755900" cy="16891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AE26D9E-E99A-7F68-1763-EB67DFDD1D2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1473" y="2028189"/>
            <a:ext cx="1796229" cy="150390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1F5727D-0872-C45A-CC1A-D084862915FA}"/>
              </a:ext>
            </a:extLst>
          </p:cNvPr>
          <p:cNvSpPr txBox="1"/>
          <p:nvPr/>
        </p:nvSpPr>
        <p:spPr>
          <a:xfrm>
            <a:off x="89704" y="-18299"/>
            <a:ext cx="291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DF01FB1-7531-B05D-2AED-3D72B5929A93}"/>
              </a:ext>
            </a:extLst>
          </p:cNvPr>
          <p:cNvSpPr txBox="1"/>
          <p:nvPr/>
        </p:nvSpPr>
        <p:spPr>
          <a:xfrm>
            <a:off x="991716" y="227954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EA695FD-1EE3-2190-63B6-984EE72212E3}"/>
              </a:ext>
            </a:extLst>
          </p:cNvPr>
          <p:cNvSpPr txBox="1"/>
          <p:nvPr/>
        </p:nvSpPr>
        <p:spPr>
          <a:xfrm>
            <a:off x="1498207" y="417179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FE56F84-C1F1-E2B4-896C-B3D554E32192}"/>
              </a:ext>
            </a:extLst>
          </p:cNvPr>
          <p:cNvSpPr txBox="1"/>
          <p:nvPr/>
        </p:nvSpPr>
        <p:spPr>
          <a:xfrm>
            <a:off x="3048839" y="229258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2F430E5-5444-003B-F011-A738EB46F8F6}"/>
              </a:ext>
            </a:extLst>
          </p:cNvPr>
          <p:cNvSpPr txBox="1"/>
          <p:nvPr/>
        </p:nvSpPr>
        <p:spPr>
          <a:xfrm>
            <a:off x="4886610" y="2342496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8EBB97F-1420-9CD6-16A9-9ADB293D7A2C}"/>
              </a:ext>
            </a:extLst>
          </p:cNvPr>
          <p:cNvSpPr txBox="1"/>
          <p:nvPr/>
        </p:nvSpPr>
        <p:spPr>
          <a:xfrm>
            <a:off x="3185832" y="4343615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E2A4E8E-7CE6-BFC9-121B-4A523DBBF714}"/>
              </a:ext>
            </a:extLst>
          </p:cNvPr>
          <p:cNvSpPr txBox="1"/>
          <p:nvPr/>
        </p:nvSpPr>
        <p:spPr>
          <a:xfrm>
            <a:off x="4964201" y="386717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***</a:t>
            </a:r>
          </a:p>
        </p:txBody>
      </p:sp>
      <p:sp>
        <p:nvSpPr>
          <p:cNvPr id="88" name="Text Box 99">
            <a:extLst>
              <a:ext uri="{FF2B5EF4-FFF2-40B4-BE49-F238E27FC236}">
                <a16:creationId xmlns:a16="http://schemas.microsoft.com/office/drawing/2014/main" id="{BA1BE686-071F-BA74-7292-A7ACCC13A906}"/>
              </a:ext>
            </a:extLst>
          </p:cNvPr>
          <p:cNvSpPr txBox="1"/>
          <p:nvPr/>
        </p:nvSpPr>
        <p:spPr>
          <a:xfrm>
            <a:off x="4071662" y="3654804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ffectLst/>
                <a:ea typeface="MS Mincho"/>
                <a:cs typeface="Times New Roman"/>
              </a:rPr>
              <a:t>I</a:t>
            </a:r>
          </a:p>
        </p:txBody>
      </p:sp>
      <p:sp>
        <p:nvSpPr>
          <p:cNvPr id="90" name="Text Box 99">
            <a:extLst>
              <a:ext uri="{FF2B5EF4-FFF2-40B4-BE49-F238E27FC236}">
                <a16:creationId xmlns:a16="http://schemas.microsoft.com/office/drawing/2014/main" id="{C244BD7D-FFA3-FE62-71D3-47401C564F61}"/>
              </a:ext>
            </a:extLst>
          </p:cNvPr>
          <p:cNvSpPr txBox="1"/>
          <p:nvPr/>
        </p:nvSpPr>
        <p:spPr>
          <a:xfrm>
            <a:off x="2161473" y="1871594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a typeface="MS Mincho"/>
                <a:cs typeface="Times New Roman"/>
              </a:rPr>
              <a:t>E</a:t>
            </a:r>
            <a:endParaRPr lang="en-US" sz="1400" b="1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91" name="Text Box 99">
            <a:extLst>
              <a:ext uri="{FF2B5EF4-FFF2-40B4-BE49-F238E27FC236}">
                <a16:creationId xmlns:a16="http://schemas.microsoft.com/office/drawing/2014/main" id="{7B6A31C1-2884-BECB-C3D8-2B1F0C69C82E}"/>
              </a:ext>
            </a:extLst>
          </p:cNvPr>
          <p:cNvSpPr txBox="1"/>
          <p:nvPr/>
        </p:nvSpPr>
        <p:spPr>
          <a:xfrm>
            <a:off x="4071662" y="1903957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ffectLst/>
                <a:ea typeface="MS Mincho"/>
                <a:cs typeface="Times New Roman"/>
              </a:rPr>
              <a:t>F</a:t>
            </a:r>
          </a:p>
        </p:txBody>
      </p:sp>
      <p:sp>
        <p:nvSpPr>
          <p:cNvPr id="95" name="Text Box 99">
            <a:extLst>
              <a:ext uri="{FF2B5EF4-FFF2-40B4-BE49-F238E27FC236}">
                <a16:creationId xmlns:a16="http://schemas.microsoft.com/office/drawing/2014/main" id="{E11CDBF0-6653-3FB3-EE15-4D9A330B7491}"/>
              </a:ext>
            </a:extLst>
          </p:cNvPr>
          <p:cNvSpPr txBox="1"/>
          <p:nvPr/>
        </p:nvSpPr>
        <p:spPr>
          <a:xfrm>
            <a:off x="98389" y="1866849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ffectLst/>
                <a:latin typeface="Calibri"/>
                <a:ea typeface="MS Mincho"/>
                <a:cs typeface="Times New Roman"/>
              </a:rPr>
              <a:t>D</a:t>
            </a:r>
            <a:endParaRPr lang="en-US" sz="1400" b="1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96" name="Text Box 99">
            <a:extLst>
              <a:ext uri="{FF2B5EF4-FFF2-40B4-BE49-F238E27FC236}">
                <a16:creationId xmlns:a16="http://schemas.microsoft.com/office/drawing/2014/main" id="{0828A17B-4E55-3F39-2061-CF060632959A}"/>
              </a:ext>
            </a:extLst>
          </p:cNvPr>
          <p:cNvSpPr txBox="1"/>
          <p:nvPr/>
        </p:nvSpPr>
        <p:spPr>
          <a:xfrm>
            <a:off x="144026" y="3638156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a typeface="MS Mincho"/>
                <a:cs typeface="Times New Roman"/>
              </a:rPr>
              <a:t>G</a:t>
            </a:r>
            <a:endParaRPr lang="en-US" sz="1400" b="1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97" name="Text Box 99">
            <a:extLst>
              <a:ext uri="{FF2B5EF4-FFF2-40B4-BE49-F238E27FC236}">
                <a16:creationId xmlns:a16="http://schemas.microsoft.com/office/drawing/2014/main" id="{CB9A3501-A6F6-8E2F-A36E-90F3C3284FB0}"/>
              </a:ext>
            </a:extLst>
          </p:cNvPr>
          <p:cNvSpPr txBox="1"/>
          <p:nvPr/>
        </p:nvSpPr>
        <p:spPr>
          <a:xfrm>
            <a:off x="2224576" y="3614738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H</a:t>
            </a:r>
            <a:endParaRPr lang="en-US" sz="1400" b="1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7877609-DCDC-E5BE-155A-306D9A38C4A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5605" y="3773611"/>
            <a:ext cx="1755894" cy="142074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480B183-DFDD-1054-BEA6-95DEA9B2E14C}"/>
              </a:ext>
            </a:extLst>
          </p:cNvPr>
          <p:cNvSpPr txBox="1"/>
          <p:nvPr/>
        </p:nvSpPr>
        <p:spPr>
          <a:xfrm>
            <a:off x="152798" y="5290514"/>
            <a:ext cx="6339435" cy="249299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 kern="100" dirty="0">
                <a:effectLst/>
                <a:latin typeface="Calibri"/>
                <a:ea typeface="Calibri"/>
                <a:cs typeface="Times New Roman"/>
              </a:rPr>
              <a:t>Supplementary Figure S1. </a:t>
            </a:r>
            <a:r>
              <a:rPr lang="en-US" sz="1200" b="1" kern="100" dirty="0" err="1">
                <a:effectLst/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 is </a:t>
            </a:r>
            <a:r>
              <a:rPr lang="en-US" sz="1200" b="1" kern="100" dirty="0">
                <a:effectLst/>
                <a:latin typeface="Calibri"/>
                <a:ea typeface="Calibri"/>
                <a:cs typeface="Times New Roman"/>
              </a:rPr>
              <a:t>a predicted TGF</a:t>
            </a:r>
            <a:r>
              <a:rPr lang="el-GR" sz="1200" b="1" kern="100" dirty="0">
                <a:effectLst/>
                <a:latin typeface="Calibri"/>
                <a:ea typeface="Calibri"/>
                <a:cs typeface="Times New Roman"/>
              </a:rPr>
              <a:t>β</a:t>
            </a:r>
            <a:r>
              <a:rPr lang="en-GB" sz="1200" b="1" kern="100" dirty="0">
                <a:effectLst/>
                <a:latin typeface="Calibri"/>
                <a:ea typeface="Calibri"/>
                <a:cs typeface="Times New Roman"/>
              </a:rPr>
              <a:t>2 modulator and induces phenotypic changes in </a:t>
            </a:r>
            <a:r>
              <a:rPr lang="en-US" sz="1200" b="1" kern="100" dirty="0">
                <a:effectLst/>
                <a:latin typeface="Calibri"/>
                <a:ea typeface="Calibri"/>
                <a:cs typeface="Times New Roman"/>
              </a:rPr>
              <a:t>c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laudin-low TNBC cells</a:t>
            </a:r>
            <a:r>
              <a:rPr lang="en-US" sz="1200" b="1" kern="100" dirty="0">
                <a:effectLst/>
                <a:latin typeface="Calibri"/>
                <a:ea typeface="Calibri"/>
                <a:cs typeface="Times New Roman"/>
              </a:rPr>
              <a:t>.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 A: 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Bar graph showing Connectivity Mapping Analysis of MDA-MB-231 data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showing that </a:t>
            </a:r>
            <a:r>
              <a:rPr lang="en-US" sz="1200" kern="100" dirty="0" err="1"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and the EGFR inhibitor, </a:t>
            </a:r>
            <a:r>
              <a:rPr lang="en-US" sz="1200" kern="100" dirty="0" err="1">
                <a:latin typeface="Calibri"/>
                <a:ea typeface="Calibri"/>
                <a:cs typeface="Times New Roman"/>
              </a:rPr>
              <a:t>Canertinib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, are predicted to reduce expression of TGF</a:t>
            </a:r>
            <a:r>
              <a:rPr lang="el-GR" sz="1200" kern="100" dirty="0">
                <a:latin typeface="Calibri"/>
                <a:ea typeface="Calibri"/>
                <a:cs typeface="Times New Roman"/>
              </a:rPr>
              <a:t>β2</a:t>
            </a:r>
            <a:r>
              <a:rPr lang="en-GB" sz="1200" kern="100" dirty="0">
                <a:latin typeface="Calibri"/>
                <a:ea typeface="Calibri"/>
                <a:cs typeface="Times New Roman"/>
              </a:rPr>
              <a:t>, in comparison to the expression of two other candidate genes. </a:t>
            </a:r>
            <a:r>
              <a:rPr lang="en-GB" sz="1200" b="1" kern="100" dirty="0">
                <a:latin typeface="Calibri"/>
                <a:ea typeface="Calibri"/>
                <a:cs typeface="Times New Roman"/>
              </a:rPr>
              <a:t>B: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Brightfield images (x20 magnification) 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of claudin-low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cell monolayers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(Hs578T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cells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) in 12-well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plates. Wound scratches were performed and images taken immediately after (0h), in vehicle control (DMSO), or 250nM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 (250nM) treated wells for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16h,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with images again taken and migration measured.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C: 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Brightfield images (x20 magnification) of claudin-low cell lines in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60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mm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dishes 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treated with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25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0nM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for 24h.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D-F: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Line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graphs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depicting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xCELLigence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migration data in MDA-MB-231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D)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,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Hs578T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E)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and MDA-MB436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F)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following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treatment with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5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0nM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relative to the DMSO control.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G-I: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 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Line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graphs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depicting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xCELLigence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invasion data in MDA-MB-231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G)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, Hs578T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H)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and MDA-MB-436 </a:t>
            </a:r>
            <a:r>
              <a:rPr lang="en-US" sz="1200" b="1" kern="100" dirty="0">
                <a:latin typeface="Calibri"/>
                <a:ea typeface="Calibri"/>
                <a:cs typeface="Times New Roman"/>
              </a:rPr>
              <a:t>(I)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following treatment with 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5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0nM </a:t>
            </a:r>
            <a:r>
              <a:rPr lang="en-US" sz="1200" kern="100" dirty="0" err="1">
                <a:effectLst/>
                <a:latin typeface="Calibri"/>
                <a:ea typeface="Calibri"/>
                <a:cs typeface="Times New Roman"/>
              </a:rPr>
              <a:t>Dasatinib</a:t>
            </a:r>
            <a:r>
              <a:rPr lang="en-US" sz="1200" kern="100" dirty="0">
                <a:effectLst/>
                <a:latin typeface="Calibri"/>
                <a:ea typeface="Calibri"/>
                <a:cs typeface="Times New Roman"/>
              </a:rPr>
              <a:t> relative to the DMSO control.</a:t>
            </a:r>
            <a:r>
              <a:rPr lang="en-US" sz="1200" kern="100" dirty="0">
                <a:latin typeface="Calibri"/>
                <a:ea typeface="Calibri"/>
                <a:cs typeface="Times New Roman"/>
              </a:rPr>
              <a:t> ***p&lt;0.0001 (t-test).</a:t>
            </a:r>
            <a:endParaRPr lang="en-US" sz="1200" kern="100" dirty="0">
              <a:effectLst/>
              <a:latin typeface="Calibri"/>
              <a:ea typeface="Calibri"/>
              <a:cs typeface="Times New Roman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BAF653F3-2497-98BF-126C-71C7D1EE7649}"/>
              </a:ext>
            </a:extLst>
          </p:cNvPr>
          <p:cNvGrpSpPr/>
          <p:nvPr/>
        </p:nvGrpSpPr>
        <p:grpSpPr>
          <a:xfrm>
            <a:off x="2234953" y="-26982"/>
            <a:ext cx="1723123" cy="1821820"/>
            <a:chOff x="2234953" y="-26982"/>
            <a:chExt cx="1723123" cy="182182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2E75864-9C83-082B-38D3-D97564D940E5}"/>
                </a:ext>
              </a:extLst>
            </p:cNvPr>
            <p:cNvSpPr txBox="1"/>
            <p:nvPr/>
          </p:nvSpPr>
          <p:spPr>
            <a:xfrm>
              <a:off x="2234953" y="-26982"/>
              <a:ext cx="2914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solidFill>
                    <a:srgbClr val="FF0000"/>
                  </a:solidFill>
                </a:rPr>
                <a:t>B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D883255-08DA-D341-4A43-9D0254F9EA15}"/>
                </a:ext>
              </a:extLst>
            </p:cNvPr>
            <p:cNvSpPr txBox="1"/>
            <p:nvPr/>
          </p:nvSpPr>
          <p:spPr>
            <a:xfrm rot="16200000">
              <a:off x="2114991" y="516702"/>
              <a:ext cx="4844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DMSO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B762AF4-807E-6F94-8F46-E480F84CA953}"/>
                </a:ext>
              </a:extLst>
            </p:cNvPr>
            <p:cNvSpPr txBox="1"/>
            <p:nvPr/>
          </p:nvSpPr>
          <p:spPr>
            <a:xfrm rot="16200000">
              <a:off x="2013667" y="1248973"/>
              <a:ext cx="6751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Dasatinib</a:t>
              </a:r>
              <a:r>
                <a:rPr lang="en-GB" sz="900" dirty="0"/>
                <a:t>  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FC77224-F50E-A8DF-E333-644E5B360427}"/>
                </a:ext>
              </a:extLst>
            </p:cNvPr>
            <p:cNvSpPr txBox="1"/>
            <p:nvPr/>
          </p:nvSpPr>
          <p:spPr>
            <a:xfrm>
              <a:off x="2666554" y="96196"/>
              <a:ext cx="3032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0h</a:t>
              </a:r>
            </a:p>
          </p:txBody>
        </p:sp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A531B9D6-580D-EA11-A703-2BA03DA9EC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26" t="33522" r="18772"/>
            <a:stretch/>
          </p:blipFill>
          <p:spPr>
            <a:xfrm rot="16200000">
              <a:off x="2436696" y="268747"/>
              <a:ext cx="744395" cy="7585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DFFB90D-33AF-F8DF-D1D2-FFCC9189C59D}"/>
                </a:ext>
              </a:extLst>
            </p:cNvPr>
            <p:cNvSpPr txBox="1"/>
            <p:nvPr/>
          </p:nvSpPr>
          <p:spPr>
            <a:xfrm>
              <a:off x="3410610" y="104663"/>
              <a:ext cx="3609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16h</a:t>
              </a:r>
            </a:p>
          </p:txBody>
        </p:sp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E0AB9D72-3EDA-0BB9-196D-242FF660AD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8" t="32273" r="24556" b="1729"/>
            <a:stretch/>
          </p:blipFill>
          <p:spPr>
            <a:xfrm rot="16200000">
              <a:off x="3209379" y="269747"/>
              <a:ext cx="742630" cy="7547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68D3CCF3-3384-4E32-9F4A-5483FCFDF7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50" t="31113" r="12000" b="2152"/>
            <a:stretch/>
          </p:blipFill>
          <p:spPr>
            <a:xfrm rot="16200000">
              <a:off x="3214371" y="1048585"/>
              <a:ext cx="736787" cy="7498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7EF40D1-BF4F-3A85-1EDD-B49933D30CBD}"/>
                </a:ext>
              </a:extLst>
            </p:cNvPr>
            <p:cNvSpPr txBox="1"/>
            <p:nvPr/>
          </p:nvSpPr>
          <p:spPr>
            <a:xfrm>
              <a:off x="2919158" y="41228"/>
              <a:ext cx="5421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HS578T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5D86BCB-8C79-7B44-EC6D-145F103319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aturation sat="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61" t="33283" r="10149"/>
            <a:stretch/>
          </p:blipFill>
          <p:spPr>
            <a:xfrm rot="16200000">
              <a:off x="2439730" y="1044259"/>
              <a:ext cx="742629" cy="7585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113ADA3A-FACB-3E94-4800-4DCED337C181}"/>
              </a:ext>
            </a:extLst>
          </p:cNvPr>
          <p:cNvGrpSpPr/>
          <p:nvPr/>
        </p:nvGrpSpPr>
        <p:grpSpPr>
          <a:xfrm>
            <a:off x="4165822" y="85570"/>
            <a:ext cx="2570494" cy="1715113"/>
            <a:chOff x="4165822" y="85570"/>
            <a:chExt cx="2570494" cy="1715113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6ABD505-2658-E65A-1657-B9EDFF54CF4B}"/>
                </a:ext>
              </a:extLst>
            </p:cNvPr>
            <p:cNvSpPr txBox="1"/>
            <p:nvPr/>
          </p:nvSpPr>
          <p:spPr>
            <a:xfrm rot="16200000">
              <a:off x="4039024" y="516702"/>
              <a:ext cx="4844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DMSO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A8954B01-731A-68A5-39C8-95217F4AA8DE}"/>
                </a:ext>
              </a:extLst>
            </p:cNvPr>
            <p:cNvSpPr txBox="1"/>
            <p:nvPr/>
          </p:nvSpPr>
          <p:spPr>
            <a:xfrm rot="16200000">
              <a:off x="3842586" y="1165644"/>
              <a:ext cx="8773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/>
                <a:t>Dasatinib</a:t>
              </a:r>
              <a:endParaRPr lang="en-GB" sz="9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2822567-A749-E3D8-09D9-04A3D0178412}"/>
                </a:ext>
              </a:extLst>
            </p:cNvPr>
            <p:cNvSpPr txBox="1"/>
            <p:nvPr/>
          </p:nvSpPr>
          <p:spPr>
            <a:xfrm>
              <a:off x="4318471" y="85570"/>
              <a:ext cx="8274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MDA-MB-23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7A5FB8D-7953-840C-CD4A-D6FC4B5E0A4C}"/>
                </a:ext>
              </a:extLst>
            </p:cNvPr>
            <p:cNvSpPr txBox="1"/>
            <p:nvPr/>
          </p:nvSpPr>
          <p:spPr>
            <a:xfrm>
              <a:off x="5223486" y="85570"/>
              <a:ext cx="5389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HS578T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0474E84-08F4-D545-F0B6-10D3446F908B}"/>
                </a:ext>
              </a:extLst>
            </p:cNvPr>
            <p:cNvSpPr txBox="1"/>
            <p:nvPr/>
          </p:nvSpPr>
          <p:spPr>
            <a:xfrm>
              <a:off x="5908845" y="85570"/>
              <a:ext cx="8274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MDA-MB-436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3B5D176-1131-8A38-51D2-B7222592D7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49" t="49637" r="34602" b="27721"/>
            <a:stretch/>
          </p:blipFill>
          <p:spPr>
            <a:xfrm>
              <a:off x="4367771" y="280796"/>
              <a:ext cx="754470" cy="7443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4FDD401-DE02-269A-00E6-026E364B03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6" t="27541" r="57924" b="49703"/>
            <a:stretch/>
          </p:blipFill>
          <p:spPr>
            <a:xfrm>
              <a:off x="5133964" y="280795"/>
              <a:ext cx="750172" cy="7443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FD9CD66-1578-5E41-2291-A6FD2F6429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064" t="72794" r="17103" b="4639"/>
            <a:stretch/>
          </p:blipFill>
          <p:spPr>
            <a:xfrm>
              <a:off x="5891210" y="285453"/>
              <a:ext cx="772683" cy="7397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0076515-C651-B5D6-1DE3-6A51CCE632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56" t="44810" r="57785" b="33710"/>
            <a:stretch/>
          </p:blipFill>
          <p:spPr>
            <a:xfrm>
              <a:off x="4364990" y="1056798"/>
              <a:ext cx="764153" cy="7436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62A0CD0F-BA73-A114-4A1A-2221B34515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907" t="28636" r="10469" b="50423"/>
            <a:stretch/>
          </p:blipFill>
          <p:spPr>
            <a:xfrm>
              <a:off x="5139565" y="1058053"/>
              <a:ext cx="751645" cy="7426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A077642-DC63-46F8-0821-BD902526BB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9" t="69955" r="78037" b="9382"/>
            <a:stretch/>
          </p:blipFill>
          <p:spPr>
            <a:xfrm>
              <a:off x="5891210" y="1058450"/>
              <a:ext cx="772683" cy="7422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70199240-546A-AC58-BF31-442F527112DE}"/>
              </a:ext>
            </a:extLst>
          </p:cNvPr>
          <p:cNvSpPr txBox="1"/>
          <p:nvPr/>
        </p:nvSpPr>
        <p:spPr>
          <a:xfrm>
            <a:off x="4135758" y="-18298"/>
            <a:ext cx="2914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</a:rPr>
              <a:t>C</a:t>
            </a:r>
          </a:p>
        </p:txBody>
      </p:sp>
      <p:pic>
        <p:nvPicPr>
          <p:cNvPr id="1026" name="m_5374309486884237575Picture 1">
            <a:extLst>
              <a:ext uri="{FF2B5EF4-FFF2-40B4-BE49-F238E27FC236}">
                <a16:creationId xmlns:a16="http://schemas.microsoft.com/office/drawing/2014/main" id="{4164333D-7154-8C4C-3679-0504C78D56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389" y="345812"/>
            <a:ext cx="2019471" cy="10266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76745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4</TotalTime>
  <Words>240</Words>
  <Application>Microsoft Office PowerPoint</Application>
  <PresentationFormat>Custom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Angel</dc:creator>
  <cp:lastModifiedBy>Werner von Gruenewaldt</cp:lastModifiedBy>
  <cp:revision>122</cp:revision>
  <dcterms:created xsi:type="dcterms:W3CDTF">2023-02-01T11:38:56Z</dcterms:created>
  <dcterms:modified xsi:type="dcterms:W3CDTF">2024-09-18T07:58:03Z</dcterms:modified>
</cp:coreProperties>
</file>